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6"/>
  </p:normalViewPr>
  <p:slideViewPr>
    <p:cSldViewPr snapToGrid="0" snapToObjects="1">
      <p:cViewPr varScale="1">
        <p:scale>
          <a:sx n="108" d="100"/>
          <a:sy n="108" d="100"/>
        </p:scale>
        <p:origin x="73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970E9A-6E3E-E344-848F-E6E7138AF35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D7FF751-3C89-1A4E-9959-70787DAAE8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0C35ED-329B-E74D-BC6D-F3045803D5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9DBF5-06E4-D04C-9B92-187F0F0A49CA}" type="datetimeFigureOut">
              <a:rPr lang="en-US" smtClean="0"/>
              <a:t>5/2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9E1E15-3652-E74F-9E5D-3AA4007E92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7B3926-CF90-8448-ABBE-A7AEB3649E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1B135-339E-9342-85A3-4C5E0476CB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15909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7E0B54-EEF4-3249-9FEC-5F4C8121E5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0CB8B4-59CB-8D40-8BA3-9F77709E49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E8CF84-6ED7-A04B-8B85-8A24EAAA18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9DBF5-06E4-D04C-9B92-187F0F0A49CA}" type="datetimeFigureOut">
              <a:rPr lang="en-US" smtClean="0"/>
              <a:t>5/2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D17113-A139-8741-B386-572A1CA137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09EF09-1748-CA41-928C-400DFDA9DE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1B135-339E-9342-85A3-4C5E0476CB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45957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00297EC-61BD-774E-AAEE-9D0010BCF46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6C50D8F-2652-3D4C-8544-D846E6BCC1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3ECCED-7F12-E44C-AF5B-B27E1EE980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9DBF5-06E4-D04C-9B92-187F0F0A49CA}" type="datetimeFigureOut">
              <a:rPr lang="en-US" smtClean="0"/>
              <a:t>5/2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8F7EF8-49E2-0645-88B3-3BBFE4273A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EB0BCC-A5F8-4D45-84B4-66B965DCB7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1B135-339E-9342-85A3-4C5E0476CB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4621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2A6B16-0897-7E45-82AD-01E9CEE201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4426D8-5218-5449-B5CB-46308DB14FE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E979F7-381D-E445-941E-87962833C9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9DBF5-06E4-D04C-9B92-187F0F0A49CA}" type="datetimeFigureOut">
              <a:rPr lang="en-US" smtClean="0"/>
              <a:t>5/2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F3AB18-FF0C-C840-B1D8-7B91372D2E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8BB723-9D4E-184D-882F-5A257C8019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1B135-339E-9342-85A3-4C5E0476CB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7893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4198DD-57A1-F746-B9EF-9F642F1D18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CA54A1-9616-C744-9222-908F2BF152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CE1423-B28D-F44A-BA59-4014FFFD4F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9DBF5-06E4-D04C-9B92-187F0F0A49CA}" type="datetimeFigureOut">
              <a:rPr lang="en-US" smtClean="0"/>
              <a:t>5/2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4CF4D4-C401-DC42-A30A-AA800BCFD1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C6D094-1FB9-B34C-990D-8FA93DBB59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1B135-339E-9342-85A3-4C5E0476CB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265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58994A-01A9-2D4D-97E6-440FF9AF8C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241588-BDAC-3A47-A232-690B3AB6C32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5353029-AE72-634D-966E-F4AE59AC0F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39CB63-B82B-4F4F-9C39-315D79E968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9DBF5-06E4-D04C-9B92-187F0F0A49CA}" type="datetimeFigureOut">
              <a:rPr lang="en-US" smtClean="0"/>
              <a:t>5/29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7366FA-F440-604B-8205-0EF42F1955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3DBD9F-0BC3-6645-A5F7-7361899205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1B135-339E-9342-85A3-4C5E0476CB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8142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EA32BD-C914-9D41-8513-B5FE0716B0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5F8784-9985-5F45-84A9-10C252D753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90F4810-00D2-1C42-834F-13D8FEE71D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5C46C45-ADA5-FE42-A69D-E8425DEE37A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DE8AF95-3825-AA40-AFAC-DBD68A911FC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9895313-7664-2B46-846B-9461B2FFB7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9DBF5-06E4-D04C-9B92-187F0F0A49CA}" type="datetimeFigureOut">
              <a:rPr lang="en-US" smtClean="0"/>
              <a:t>5/29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F2ECD51-097E-8544-846F-EDEC00C4FD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112AFBD-1D98-6544-A82A-EDE34436B2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1B135-339E-9342-85A3-4C5E0476CB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21741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A7A2A3-C2B8-B14A-BB25-EA565C2BCE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2280BF0-75D1-854D-8960-46A3279632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9DBF5-06E4-D04C-9B92-187F0F0A49CA}" type="datetimeFigureOut">
              <a:rPr lang="en-US" smtClean="0"/>
              <a:t>5/29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28928BE-79DA-8948-A6D8-5446118930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3B864ED-CC39-F542-9093-CF6C473838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1B135-339E-9342-85A3-4C5E0476CB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9028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9B370CB-8AB0-F045-9108-6ADDEBB975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9DBF5-06E4-D04C-9B92-187F0F0A49CA}" type="datetimeFigureOut">
              <a:rPr lang="en-US" smtClean="0"/>
              <a:t>5/29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0D96CFC-E599-064D-AC46-30A2E886FE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4B3D766-0E1D-424F-8E79-0CC82977E5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1B135-339E-9342-85A3-4C5E0476CB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58042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58B07A-5DB1-3A41-96C0-096D0A0595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F8B84B-1EBF-4B48-9C62-A40B9B3F57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4823671-D64B-B141-89AB-D823DDBB46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FEB305-3A10-9F41-B668-28A1819F37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9DBF5-06E4-D04C-9B92-187F0F0A49CA}" type="datetimeFigureOut">
              <a:rPr lang="en-US" smtClean="0"/>
              <a:t>5/29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99E1F0-5092-3243-8941-3F4B157865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AE5A13-A534-3D4F-9DD4-06DA46688A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1B135-339E-9342-85A3-4C5E0476CB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6020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11D17E-9D74-2149-91DA-1305FC7B82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3BC501B-45AB-1148-88DE-DF0DDE5BCD4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C5C59DF-6CF3-7643-81B2-AA6A524800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4F5448-2FBA-3B4A-9871-6A848E95BE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9DBF5-06E4-D04C-9B92-187F0F0A49CA}" type="datetimeFigureOut">
              <a:rPr lang="en-US" smtClean="0"/>
              <a:t>5/29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2DEF66-DEAB-9C4A-A43E-06CEE36BD3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012708-0C86-7F48-9497-B17162579F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1B135-339E-9342-85A3-4C5E0476CB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649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B6FEE87-578B-1E4D-A66D-33815E5B90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994499-7B5B-CD47-B9F0-BE47613CAE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7A4F83-E689-7745-8778-D197F6962D0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A9DBF5-06E4-D04C-9B92-187F0F0A49CA}" type="datetimeFigureOut">
              <a:rPr lang="en-US" smtClean="0"/>
              <a:t>5/2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B25FDA-DC2F-7D47-9B0D-D12DB70826A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60C09F-762B-044A-8D9A-4D80E918FF1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71B135-339E-9342-85A3-4C5E0476CB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17280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6BAB8F5-83EA-0540-ABE4-39965779303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796" t="34113" r="18110" b="23982"/>
          <a:stretch/>
        </p:blipFill>
        <p:spPr>
          <a:xfrm>
            <a:off x="178130" y="1163781"/>
            <a:ext cx="5635918" cy="233943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84BE835-8E08-E34A-B324-C7B7B6E34030}"/>
              </a:ext>
            </a:extLst>
          </p:cNvPr>
          <p:cNvSpPr txBox="1"/>
          <p:nvPr/>
        </p:nvSpPr>
        <p:spPr>
          <a:xfrm>
            <a:off x="2327563" y="878774"/>
            <a:ext cx="10034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MT1M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8B84A8F-5EA1-5A47-A9C8-69871AB847A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9120" t="23723" r="18110" b="34546"/>
          <a:stretch/>
        </p:blipFill>
        <p:spPr>
          <a:xfrm>
            <a:off x="178130" y="4308359"/>
            <a:ext cx="5635918" cy="234182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3760515-C282-5743-A0D5-A5664E7BEEE3}"/>
              </a:ext>
            </a:extLst>
          </p:cNvPr>
          <p:cNvSpPr txBox="1"/>
          <p:nvPr/>
        </p:nvSpPr>
        <p:spPr>
          <a:xfrm>
            <a:off x="2327562" y="3805248"/>
            <a:ext cx="10034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MT1A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04C69C54-1313-FA4D-9CEE-BA4E89FE809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9227" t="23723" r="18111" b="34199"/>
          <a:stretch/>
        </p:blipFill>
        <p:spPr>
          <a:xfrm>
            <a:off x="6071025" y="1163781"/>
            <a:ext cx="5579897" cy="234182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1EFF1A0E-E8DB-6146-9376-FBACD223D972}"/>
              </a:ext>
            </a:extLst>
          </p:cNvPr>
          <p:cNvSpPr txBox="1"/>
          <p:nvPr/>
        </p:nvSpPr>
        <p:spPr>
          <a:xfrm>
            <a:off x="8359240" y="878774"/>
            <a:ext cx="10034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MT2A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6B74C7CD-FFCF-3746-A5F2-B75AB87B91F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9012" t="32727" r="17568" b="24156"/>
          <a:stretch/>
        </p:blipFill>
        <p:spPr>
          <a:xfrm>
            <a:off x="6096000" y="4193181"/>
            <a:ext cx="5782339" cy="2457001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5B66296C-93E8-BC46-9D22-0F3069403502}"/>
              </a:ext>
            </a:extLst>
          </p:cNvPr>
          <p:cNvSpPr txBox="1"/>
          <p:nvPr/>
        </p:nvSpPr>
        <p:spPr>
          <a:xfrm>
            <a:off x="8359240" y="3790611"/>
            <a:ext cx="10034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MT1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24AC51D-598B-7F48-BF1D-AF68A743CBE3}"/>
              </a:ext>
            </a:extLst>
          </p:cNvPr>
          <p:cNvSpPr txBox="1"/>
          <p:nvPr/>
        </p:nvSpPr>
        <p:spPr>
          <a:xfrm>
            <a:off x="273132" y="237506"/>
            <a:ext cx="1160520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3. </a:t>
            </a:r>
            <a:r>
              <a:rPr lang="en-US" dirty="0"/>
              <a:t>Representative graphs of metallothionein expression downloaded from human protein atlas (</a:t>
            </a:r>
            <a:r>
              <a:rPr lang="en-US" dirty="0" err="1"/>
              <a:t>proteinatlas.org</a:t>
            </a:r>
            <a:r>
              <a:rPr lang="en-US" dirty="0"/>
              <a:t>) shows liver enrichment of </a:t>
            </a:r>
            <a:r>
              <a:rPr lang="en-US"/>
              <a:t>metallothionein gene expression</a:t>
            </a:r>
            <a:r>
              <a:rPr lang="en-US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18658528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31</Words>
  <Application>Microsoft Macintosh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agyan Acharya</dc:creator>
  <cp:lastModifiedBy>Pragyan Acharya</cp:lastModifiedBy>
  <cp:revision>5</cp:revision>
  <dcterms:created xsi:type="dcterms:W3CDTF">2022-05-29T08:20:01Z</dcterms:created>
  <dcterms:modified xsi:type="dcterms:W3CDTF">2022-05-29T08:29:11Z</dcterms:modified>
</cp:coreProperties>
</file>